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552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273A-CDD7-484D-98CF-0CCE0AAB73FB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5DA-3716-4D6E-9172-DF4323A4E37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22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273A-CDD7-484D-98CF-0CCE0AAB73FB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5DA-3716-4D6E-9172-DF4323A4E37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3741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273A-CDD7-484D-98CF-0CCE0AAB73FB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5DA-3716-4D6E-9172-DF4323A4E37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0498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273A-CDD7-484D-98CF-0CCE0AAB73FB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5DA-3716-4D6E-9172-DF4323A4E37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0473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273A-CDD7-484D-98CF-0CCE0AAB73FB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5DA-3716-4D6E-9172-DF4323A4E37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23372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273A-CDD7-484D-98CF-0CCE0AAB73FB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5DA-3716-4D6E-9172-DF4323A4E37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9542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273A-CDD7-484D-98CF-0CCE0AAB73FB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5DA-3716-4D6E-9172-DF4323A4E37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81366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273A-CDD7-484D-98CF-0CCE0AAB73FB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5DA-3716-4D6E-9172-DF4323A4E37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206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273A-CDD7-484D-98CF-0CCE0AAB73FB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5DA-3716-4D6E-9172-DF4323A4E37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2831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273A-CDD7-484D-98CF-0CCE0AAB73FB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5DA-3716-4D6E-9172-DF4323A4E37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0704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273A-CDD7-484D-98CF-0CCE0AAB73FB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5DA-3716-4D6E-9172-DF4323A4E37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90984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68273A-CDD7-484D-98CF-0CCE0AAB73FB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2485DA-3716-4D6E-9172-DF4323A4E37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3816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9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Bildplatzhalter 4"/>
          <p:cNvPicPr>
            <a:picLocks noGrp="1" noChangeAspect="1"/>
          </p:cNvPicPr>
          <p:nvPr>
            <p:ph type="pic" idx="1"/>
          </p:nvPr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471" t="49270" r="31731" b="12286"/>
          <a:stretch/>
        </p:blipFill>
        <p:spPr>
          <a:xfrm>
            <a:off x="5226467" y="261758"/>
            <a:ext cx="1855695" cy="1873623"/>
          </a:xfrm>
        </p:spPr>
      </p:pic>
      <p:pic>
        <p:nvPicPr>
          <p:cNvPr id="6" name="Bildplatzhalter 4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217" t="9906" r="28972" b="52385"/>
          <a:stretch/>
        </p:blipFill>
        <p:spPr>
          <a:xfrm>
            <a:off x="2705285" y="261759"/>
            <a:ext cx="2449420" cy="1873623"/>
          </a:xfrm>
          <a:prstGeom prst="rect">
            <a:avLst/>
          </a:prstGeom>
        </p:spPr>
      </p:pic>
      <p:pic>
        <p:nvPicPr>
          <p:cNvPr id="7" name="Bildplatzhalter 4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28" t="25331" r="68750" b="27027"/>
          <a:stretch/>
        </p:blipFill>
        <p:spPr>
          <a:xfrm>
            <a:off x="1027560" y="261759"/>
            <a:ext cx="1605963" cy="1873623"/>
          </a:xfrm>
          <a:prstGeom prst="rect">
            <a:avLst/>
          </a:prstGeom>
        </p:spPr>
      </p:pic>
      <p:pic>
        <p:nvPicPr>
          <p:cNvPr id="8" name="Bildplatzhalter 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451" t="49491" r="9337" b="12543"/>
          <a:stretch/>
        </p:blipFill>
        <p:spPr>
          <a:xfrm>
            <a:off x="5226467" y="2565685"/>
            <a:ext cx="1828585" cy="1436149"/>
          </a:xfrm>
          <a:prstGeom prst="rect">
            <a:avLst/>
          </a:prstGeom>
        </p:spPr>
      </p:pic>
      <p:pic>
        <p:nvPicPr>
          <p:cNvPr id="9" name="Bildplatzhalter 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358" t="9502" r="4807" b="52311"/>
          <a:stretch/>
        </p:blipFill>
        <p:spPr>
          <a:xfrm>
            <a:off x="2697479" y="2565685"/>
            <a:ext cx="2457226" cy="1436149"/>
          </a:xfrm>
          <a:prstGeom prst="rect">
            <a:avLst/>
          </a:prstGeom>
        </p:spPr>
      </p:pic>
      <p:pic>
        <p:nvPicPr>
          <p:cNvPr id="10" name="Bildplatzhalter 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95" t="17632" r="57116" b="13059"/>
          <a:stretch/>
        </p:blipFill>
        <p:spPr>
          <a:xfrm>
            <a:off x="1027560" y="2372046"/>
            <a:ext cx="1598157" cy="2007285"/>
          </a:xfrm>
          <a:prstGeom prst="rect">
            <a:avLst/>
          </a:prstGeom>
        </p:spPr>
      </p:pic>
      <p:pic>
        <p:nvPicPr>
          <p:cNvPr id="11" name="Bildplatzhalter 4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486" t="49270" r="13061" b="12544"/>
          <a:stretch/>
        </p:blipFill>
        <p:spPr>
          <a:xfrm>
            <a:off x="5226467" y="4660729"/>
            <a:ext cx="1900773" cy="1985977"/>
          </a:xfrm>
          <a:prstGeom prst="rect">
            <a:avLst/>
          </a:prstGeom>
        </p:spPr>
      </p:pic>
      <p:pic>
        <p:nvPicPr>
          <p:cNvPr id="12" name="Bildplatzhalter 4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428" t="8839" r="9360" b="52091"/>
          <a:stretch/>
        </p:blipFill>
        <p:spPr>
          <a:xfrm>
            <a:off x="2697479" y="4660730"/>
            <a:ext cx="2457226" cy="1985977"/>
          </a:xfrm>
          <a:prstGeom prst="rect">
            <a:avLst/>
          </a:prstGeom>
        </p:spPr>
      </p:pic>
      <p:pic>
        <p:nvPicPr>
          <p:cNvPr id="13" name="Bildplatzhalter 4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89" t="20713" r="59461" b="18941"/>
          <a:stretch/>
        </p:blipFill>
        <p:spPr>
          <a:xfrm>
            <a:off x="1027560" y="4660729"/>
            <a:ext cx="1598157" cy="1985977"/>
          </a:xfrm>
          <a:prstGeom prst="rect">
            <a:avLst/>
          </a:prstGeom>
        </p:spPr>
      </p:pic>
      <p:sp>
        <p:nvSpPr>
          <p:cNvPr id="14" name="Rechteck 13"/>
          <p:cNvSpPr/>
          <p:nvPr/>
        </p:nvSpPr>
        <p:spPr>
          <a:xfrm>
            <a:off x="150607" y="64719"/>
            <a:ext cx="7293685" cy="679328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3" name="Rechteck 42"/>
          <p:cNvSpPr/>
          <p:nvPr/>
        </p:nvSpPr>
        <p:spPr>
          <a:xfrm>
            <a:off x="290456" y="185279"/>
            <a:ext cx="7046259" cy="200926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4" name="Rechteck 43"/>
          <p:cNvSpPr/>
          <p:nvPr/>
        </p:nvSpPr>
        <p:spPr>
          <a:xfrm>
            <a:off x="290456" y="2318247"/>
            <a:ext cx="7041714" cy="214346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5" name="Rechteck 44"/>
          <p:cNvSpPr/>
          <p:nvPr/>
        </p:nvSpPr>
        <p:spPr>
          <a:xfrm>
            <a:off x="290456" y="4585415"/>
            <a:ext cx="7041714" cy="214346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6" name="Textfeld 45"/>
          <p:cNvSpPr txBox="1"/>
          <p:nvPr/>
        </p:nvSpPr>
        <p:spPr>
          <a:xfrm>
            <a:off x="361211" y="22112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A</a:t>
            </a:r>
          </a:p>
        </p:txBody>
      </p:sp>
      <p:sp>
        <p:nvSpPr>
          <p:cNvPr id="47" name="Textfeld 46"/>
          <p:cNvSpPr txBox="1"/>
          <p:nvPr/>
        </p:nvSpPr>
        <p:spPr>
          <a:xfrm>
            <a:off x="361211" y="2372046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B</a:t>
            </a:r>
          </a:p>
        </p:txBody>
      </p:sp>
      <p:sp>
        <p:nvSpPr>
          <p:cNvPr id="48" name="Textfeld 47"/>
          <p:cNvSpPr txBox="1"/>
          <p:nvPr/>
        </p:nvSpPr>
        <p:spPr>
          <a:xfrm>
            <a:off x="361211" y="4660730"/>
            <a:ext cx="250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C</a:t>
            </a:r>
          </a:p>
        </p:txBody>
      </p:sp>
      <p:cxnSp>
        <p:nvCxnSpPr>
          <p:cNvPr id="50" name="Gerade Verbindung mit Pfeil 49"/>
          <p:cNvCxnSpPr/>
          <p:nvPr/>
        </p:nvCxnSpPr>
        <p:spPr>
          <a:xfrm flipV="1">
            <a:off x="1213889" y="1286730"/>
            <a:ext cx="389849" cy="25704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 Verbindung mit Pfeil 51"/>
          <p:cNvCxnSpPr/>
          <p:nvPr/>
        </p:nvCxnSpPr>
        <p:spPr>
          <a:xfrm flipV="1">
            <a:off x="1151130" y="3655205"/>
            <a:ext cx="389849" cy="25704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Gerade Verbindung mit Pfeil 52"/>
          <p:cNvCxnSpPr/>
          <p:nvPr/>
        </p:nvCxnSpPr>
        <p:spPr>
          <a:xfrm flipV="1">
            <a:off x="1206708" y="5808528"/>
            <a:ext cx="389849" cy="25704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Gerade Verbindung mit Pfeil 53"/>
          <p:cNvCxnSpPr/>
          <p:nvPr/>
        </p:nvCxnSpPr>
        <p:spPr>
          <a:xfrm flipH="1">
            <a:off x="4113817" y="5073094"/>
            <a:ext cx="200003" cy="274649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Gerade Verbindung mit Pfeil 55"/>
          <p:cNvCxnSpPr/>
          <p:nvPr/>
        </p:nvCxnSpPr>
        <p:spPr>
          <a:xfrm flipH="1">
            <a:off x="4513645" y="2686691"/>
            <a:ext cx="200003" cy="274649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Gerade Verbindung mit Pfeil 56"/>
          <p:cNvCxnSpPr/>
          <p:nvPr/>
        </p:nvCxnSpPr>
        <p:spPr>
          <a:xfrm flipH="1">
            <a:off x="4113817" y="590458"/>
            <a:ext cx="200003" cy="274649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Gerade Verbindung mit Pfeil 58"/>
          <p:cNvCxnSpPr/>
          <p:nvPr/>
        </p:nvCxnSpPr>
        <p:spPr>
          <a:xfrm>
            <a:off x="5765384" y="633490"/>
            <a:ext cx="193352" cy="268387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Gerade Verbindung mit Pfeil 60"/>
          <p:cNvCxnSpPr/>
          <p:nvPr/>
        </p:nvCxnSpPr>
        <p:spPr>
          <a:xfrm>
            <a:off x="5756417" y="2797571"/>
            <a:ext cx="193352" cy="268387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Gerade Verbindung mit Pfeil 62"/>
          <p:cNvCxnSpPr/>
          <p:nvPr/>
        </p:nvCxnSpPr>
        <p:spPr>
          <a:xfrm>
            <a:off x="5796953" y="5132569"/>
            <a:ext cx="193352" cy="268387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feld 1">
            <a:extLst>
              <a:ext uri="{FF2B5EF4-FFF2-40B4-BE49-F238E27FC236}">
                <a16:creationId xmlns:a16="http://schemas.microsoft.com/office/drawing/2014/main" id="{AFEBD3FF-DDA1-40E4-954D-09E00953E5E6}"/>
              </a:ext>
            </a:extLst>
          </p:cNvPr>
          <p:cNvSpPr txBox="1"/>
          <p:nvPr/>
        </p:nvSpPr>
        <p:spPr>
          <a:xfrm>
            <a:off x="7601992" y="40235"/>
            <a:ext cx="2931836" cy="3231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GB" sz="1200" b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</a:t>
            </a:r>
            <a:r>
              <a:rPr lang="en-GB" sz="12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2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eoperative MRI, MRI after first surgery and MRI after second surgery (</a:t>
            </a:r>
            <a:r>
              <a:rPr lang="en-GB" sz="1200" b="1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ereotactically</a:t>
            </a:r>
            <a:r>
              <a:rPr lang="en-GB" sz="12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uided approach).</a:t>
            </a:r>
            <a:r>
              <a:rPr lang="en-GB" sz="12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GB" sz="1200" b="1" dirty="0"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GB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eoperative MRI shows a cavernoma in the right dorsal splenium in axial, coronal and sagittal reconstructions in T2 weighted sequence (</a:t>
            </a:r>
            <a:r>
              <a:rPr lang="en-GB" sz="12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First postoperative MRI after </a:t>
            </a:r>
            <a:r>
              <a:rPr lang="en-GB" sz="12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uronavigated</a:t>
            </a:r>
            <a:r>
              <a:rPr lang="en-GB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rosurgery shows the incorrect approach (</a:t>
            </a:r>
            <a:r>
              <a:rPr lang="en-GB" sz="12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red arrows). Second postoperative MRI shows the correct approach and complete resection of the cavernoma using the </a:t>
            </a:r>
            <a:r>
              <a:rPr lang="en-GB" sz="12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ereotactically</a:t>
            </a:r>
            <a:r>
              <a:rPr lang="en-GB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uided microsurgical approach (</a:t>
            </a:r>
            <a:r>
              <a:rPr lang="en-GB" sz="12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red arrows).</a:t>
            </a:r>
            <a:endParaRPr lang="de-DE" sz="12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de-DE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1369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</vt:lpstr>
      <vt:lpstr>PowerPoint Presentation</vt:lpstr>
    </vt:vector>
  </TitlesOfParts>
  <Company>Klinikum der Universitaet Muench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dmin</dc:creator>
  <cp:lastModifiedBy>MDPI</cp:lastModifiedBy>
  <cp:revision>24</cp:revision>
  <cp:lastPrinted>2020-05-26T15:11:18Z</cp:lastPrinted>
  <dcterms:created xsi:type="dcterms:W3CDTF">2020-04-23T15:13:57Z</dcterms:created>
  <dcterms:modified xsi:type="dcterms:W3CDTF">2025-06-12T10:10:49Z</dcterms:modified>
</cp:coreProperties>
</file>